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7704138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45" userDrawn="1">
          <p15:clr>
            <a:srgbClr val="A4A3A4"/>
          </p15:clr>
        </p15:guide>
        <p15:guide id="2" pos="24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997"/>
    <p:restoredTop sz="95584"/>
  </p:normalViewPr>
  <p:slideViewPr>
    <p:cSldViewPr snapToGrid="0" showGuides="1">
      <p:cViewPr varScale="1">
        <p:scale>
          <a:sx n="64" d="100"/>
          <a:sy n="64" d="100"/>
        </p:scale>
        <p:origin x="2768" y="176"/>
      </p:cViewPr>
      <p:guideLst>
        <p:guide orient="horz" pos="3345"/>
        <p:guide pos="24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0FA8CD-9D7E-AA44-8CE8-89FD531BB4B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1143000"/>
            <a:ext cx="2222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A4BE5B-53B7-7944-A537-F7DCBFA870A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15058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A4BE5B-53B7-7944-A537-F7DCBFA870AF}" type="slidenum">
              <a:rPr lang="en-JP" smtClean="0"/>
              <a:t>4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760429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A4BE5B-53B7-7944-A537-F7DCBFA870AF}" type="slidenum">
              <a:rPr lang="en-JP" smtClean="0"/>
              <a:t>5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184546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A4BE5B-53B7-7944-A537-F7DCBFA870AF}" type="slidenum">
              <a:rPr lang="en-JP" smtClean="0"/>
              <a:t>6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282527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77811" y="1749795"/>
            <a:ext cx="6548517" cy="3722335"/>
          </a:xfrm>
        </p:spPr>
        <p:txBody>
          <a:bodyPr anchor="b"/>
          <a:lstStyle>
            <a:lvl1pPr algn="ctr">
              <a:defRPr sz="50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3017" y="5615678"/>
            <a:ext cx="5778104" cy="2581379"/>
          </a:xfrm>
        </p:spPr>
        <p:txBody>
          <a:bodyPr/>
          <a:lstStyle>
            <a:lvl1pPr marL="0" indent="0" algn="ctr">
              <a:buNone/>
              <a:defRPr sz="2022"/>
            </a:lvl1pPr>
            <a:lvl2pPr marL="385191" indent="0" algn="ctr">
              <a:buNone/>
              <a:defRPr sz="1685"/>
            </a:lvl2pPr>
            <a:lvl3pPr marL="770382" indent="0" algn="ctr">
              <a:buNone/>
              <a:defRPr sz="1517"/>
            </a:lvl3pPr>
            <a:lvl4pPr marL="1155573" indent="0" algn="ctr">
              <a:buNone/>
              <a:defRPr sz="1348"/>
            </a:lvl4pPr>
            <a:lvl5pPr marL="1540764" indent="0" algn="ctr">
              <a:buNone/>
              <a:defRPr sz="1348"/>
            </a:lvl5pPr>
            <a:lvl6pPr marL="1925955" indent="0" algn="ctr">
              <a:buNone/>
              <a:defRPr sz="1348"/>
            </a:lvl6pPr>
            <a:lvl7pPr marL="2311146" indent="0" algn="ctr">
              <a:buNone/>
              <a:defRPr sz="1348"/>
            </a:lvl7pPr>
            <a:lvl8pPr marL="2696337" indent="0" algn="ctr">
              <a:buNone/>
              <a:defRPr sz="1348"/>
            </a:lvl8pPr>
            <a:lvl9pPr marL="3081528" indent="0" algn="ctr">
              <a:buNone/>
              <a:defRPr sz="134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52536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967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13274" y="569240"/>
            <a:ext cx="166120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9660" y="569240"/>
            <a:ext cx="4887313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89460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41665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5647" y="2665532"/>
            <a:ext cx="6644819" cy="4447496"/>
          </a:xfrm>
        </p:spPr>
        <p:txBody>
          <a:bodyPr anchor="b"/>
          <a:lstStyle>
            <a:lvl1pPr>
              <a:defRPr sz="50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647" y="7155103"/>
            <a:ext cx="6644819" cy="2338833"/>
          </a:xfrm>
        </p:spPr>
        <p:txBody>
          <a:bodyPr/>
          <a:lstStyle>
            <a:lvl1pPr marL="0" indent="0">
              <a:buNone/>
              <a:defRPr sz="2022">
                <a:solidFill>
                  <a:schemeClr val="tx1"/>
                </a:solidFill>
              </a:defRPr>
            </a:lvl1pPr>
            <a:lvl2pPr marL="385191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2pPr>
            <a:lvl3pPr marL="770382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3pPr>
            <a:lvl4pPr marL="1155573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4pPr>
            <a:lvl5pPr marL="1540764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5pPr>
            <a:lvl6pPr marL="1925955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6pPr>
            <a:lvl7pPr marL="2311146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7pPr>
            <a:lvl8pPr marL="2696337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8pPr>
            <a:lvl9pPr marL="3081528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1451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9659" y="2846200"/>
            <a:ext cx="3274259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00220" y="2846200"/>
            <a:ext cx="3274259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8128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663" y="569242"/>
            <a:ext cx="6644819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664" y="2620980"/>
            <a:ext cx="3259211" cy="1284502"/>
          </a:xfrm>
        </p:spPr>
        <p:txBody>
          <a:bodyPr anchor="b"/>
          <a:lstStyle>
            <a:lvl1pPr marL="0" indent="0">
              <a:buNone/>
              <a:defRPr sz="2022" b="1"/>
            </a:lvl1pPr>
            <a:lvl2pPr marL="385191" indent="0">
              <a:buNone/>
              <a:defRPr sz="1685" b="1"/>
            </a:lvl2pPr>
            <a:lvl3pPr marL="770382" indent="0">
              <a:buNone/>
              <a:defRPr sz="1517" b="1"/>
            </a:lvl3pPr>
            <a:lvl4pPr marL="1155573" indent="0">
              <a:buNone/>
              <a:defRPr sz="1348" b="1"/>
            </a:lvl4pPr>
            <a:lvl5pPr marL="1540764" indent="0">
              <a:buNone/>
              <a:defRPr sz="1348" b="1"/>
            </a:lvl5pPr>
            <a:lvl6pPr marL="1925955" indent="0">
              <a:buNone/>
              <a:defRPr sz="1348" b="1"/>
            </a:lvl6pPr>
            <a:lvl7pPr marL="2311146" indent="0">
              <a:buNone/>
              <a:defRPr sz="1348" b="1"/>
            </a:lvl7pPr>
            <a:lvl8pPr marL="2696337" indent="0">
              <a:buNone/>
              <a:defRPr sz="1348" b="1"/>
            </a:lvl8pPr>
            <a:lvl9pPr marL="3081528" indent="0">
              <a:buNone/>
              <a:defRPr sz="134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0664" y="3905482"/>
            <a:ext cx="3259211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00220" y="2620980"/>
            <a:ext cx="3275262" cy="1284502"/>
          </a:xfrm>
        </p:spPr>
        <p:txBody>
          <a:bodyPr anchor="b"/>
          <a:lstStyle>
            <a:lvl1pPr marL="0" indent="0">
              <a:buNone/>
              <a:defRPr sz="2022" b="1"/>
            </a:lvl1pPr>
            <a:lvl2pPr marL="385191" indent="0">
              <a:buNone/>
              <a:defRPr sz="1685" b="1"/>
            </a:lvl2pPr>
            <a:lvl3pPr marL="770382" indent="0">
              <a:buNone/>
              <a:defRPr sz="1517" b="1"/>
            </a:lvl3pPr>
            <a:lvl4pPr marL="1155573" indent="0">
              <a:buNone/>
              <a:defRPr sz="1348" b="1"/>
            </a:lvl4pPr>
            <a:lvl5pPr marL="1540764" indent="0">
              <a:buNone/>
              <a:defRPr sz="1348" b="1"/>
            </a:lvl5pPr>
            <a:lvl6pPr marL="1925955" indent="0">
              <a:buNone/>
              <a:defRPr sz="1348" b="1"/>
            </a:lvl6pPr>
            <a:lvl7pPr marL="2311146" indent="0">
              <a:buNone/>
              <a:defRPr sz="1348" b="1"/>
            </a:lvl7pPr>
            <a:lvl8pPr marL="2696337" indent="0">
              <a:buNone/>
              <a:defRPr sz="1348" b="1"/>
            </a:lvl8pPr>
            <a:lvl9pPr marL="3081528" indent="0">
              <a:buNone/>
              <a:defRPr sz="134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00220" y="3905482"/>
            <a:ext cx="3275262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76872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7221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11955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663" y="712788"/>
            <a:ext cx="2484785" cy="2494756"/>
          </a:xfrm>
        </p:spPr>
        <p:txBody>
          <a:bodyPr anchor="b"/>
          <a:lstStyle>
            <a:lvl1pPr>
              <a:defRPr sz="26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75262" y="1539425"/>
            <a:ext cx="3900220" cy="7598117"/>
          </a:xfrm>
        </p:spPr>
        <p:txBody>
          <a:bodyPr/>
          <a:lstStyle>
            <a:lvl1pPr>
              <a:defRPr sz="2696"/>
            </a:lvl1pPr>
            <a:lvl2pPr>
              <a:defRPr sz="2359"/>
            </a:lvl2pPr>
            <a:lvl3pPr>
              <a:defRPr sz="2022"/>
            </a:lvl3pPr>
            <a:lvl4pPr>
              <a:defRPr sz="1685"/>
            </a:lvl4pPr>
            <a:lvl5pPr>
              <a:defRPr sz="1685"/>
            </a:lvl5pPr>
            <a:lvl6pPr>
              <a:defRPr sz="1685"/>
            </a:lvl6pPr>
            <a:lvl7pPr>
              <a:defRPr sz="1685"/>
            </a:lvl7pPr>
            <a:lvl8pPr>
              <a:defRPr sz="1685"/>
            </a:lvl8pPr>
            <a:lvl9pPr>
              <a:defRPr sz="168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0663" y="3207544"/>
            <a:ext cx="2484785" cy="5942372"/>
          </a:xfrm>
        </p:spPr>
        <p:txBody>
          <a:bodyPr/>
          <a:lstStyle>
            <a:lvl1pPr marL="0" indent="0">
              <a:buNone/>
              <a:defRPr sz="1348"/>
            </a:lvl1pPr>
            <a:lvl2pPr marL="385191" indent="0">
              <a:buNone/>
              <a:defRPr sz="1180"/>
            </a:lvl2pPr>
            <a:lvl3pPr marL="770382" indent="0">
              <a:buNone/>
              <a:defRPr sz="1011"/>
            </a:lvl3pPr>
            <a:lvl4pPr marL="1155573" indent="0">
              <a:buNone/>
              <a:defRPr sz="843"/>
            </a:lvl4pPr>
            <a:lvl5pPr marL="1540764" indent="0">
              <a:buNone/>
              <a:defRPr sz="843"/>
            </a:lvl5pPr>
            <a:lvl6pPr marL="1925955" indent="0">
              <a:buNone/>
              <a:defRPr sz="843"/>
            </a:lvl6pPr>
            <a:lvl7pPr marL="2311146" indent="0">
              <a:buNone/>
              <a:defRPr sz="843"/>
            </a:lvl7pPr>
            <a:lvl8pPr marL="2696337" indent="0">
              <a:buNone/>
              <a:defRPr sz="843"/>
            </a:lvl8pPr>
            <a:lvl9pPr marL="3081528" indent="0">
              <a:buNone/>
              <a:defRPr sz="84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46471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663" y="712788"/>
            <a:ext cx="2484785" cy="2494756"/>
          </a:xfrm>
        </p:spPr>
        <p:txBody>
          <a:bodyPr anchor="b"/>
          <a:lstStyle>
            <a:lvl1pPr>
              <a:defRPr sz="26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75262" y="1539425"/>
            <a:ext cx="3900220" cy="7598117"/>
          </a:xfrm>
        </p:spPr>
        <p:txBody>
          <a:bodyPr anchor="t"/>
          <a:lstStyle>
            <a:lvl1pPr marL="0" indent="0">
              <a:buNone/>
              <a:defRPr sz="2696"/>
            </a:lvl1pPr>
            <a:lvl2pPr marL="385191" indent="0">
              <a:buNone/>
              <a:defRPr sz="2359"/>
            </a:lvl2pPr>
            <a:lvl3pPr marL="770382" indent="0">
              <a:buNone/>
              <a:defRPr sz="2022"/>
            </a:lvl3pPr>
            <a:lvl4pPr marL="1155573" indent="0">
              <a:buNone/>
              <a:defRPr sz="1685"/>
            </a:lvl4pPr>
            <a:lvl5pPr marL="1540764" indent="0">
              <a:buNone/>
              <a:defRPr sz="1685"/>
            </a:lvl5pPr>
            <a:lvl6pPr marL="1925955" indent="0">
              <a:buNone/>
              <a:defRPr sz="1685"/>
            </a:lvl6pPr>
            <a:lvl7pPr marL="2311146" indent="0">
              <a:buNone/>
              <a:defRPr sz="1685"/>
            </a:lvl7pPr>
            <a:lvl8pPr marL="2696337" indent="0">
              <a:buNone/>
              <a:defRPr sz="1685"/>
            </a:lvl8pPr>
            <a:lvl9pPr marL="3081528" indent="0">
              <a:buNone/>
              <a:defRPr sz="168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0663" y="3207544"/>
            <a:ext cx="2484785" cy="5942372"/>
          </a:xfrm>
        </p:spPr>
        <p:txBody>
          <a:bodyPr/>
          <a:lstStyle>
            <a:lvl1pPr marL="0" indent="0">
              <a:buNone/>
              <a:defRPr sz="1348"/>
            </a:lvl1pPr>
            <a:lvl2pPr marL="385191" indent="0">
              <a:buNone/>
              <a:defRPr sz="1180"/>
            </a:lvl2pPr>
            <a:lvl3pPr marL="770382" indent="0">
              <a:buNone/>
              <a:defRPr sz="1011"/>
            </a:lvl3pPr>
            <a:lvl4pPr marL="1155573" indent="0">
              <a:buNone/>
              <a:defRPr sz="843"/>
            </a:lvl4pPr>
            <a:lvl5pPr marL="1540764" indent="0">
              <a:buNone/>
              <a:defRPr sz="843"/>
            </a:lvl5pPr>
            <a:lvl6pPr marL="1925955" indent="0">
              <a:buNone/>
              <a:defRPr sz="843"/>
            </a:lvl6pPr>
            <a:lvl7pPr marL="2311146" indent="0">
              <a:buNone/>
              <a:defRPr sz="843"/>
            </a:lvl7pPr>
            <a:lvl8pPr marL="2696337" indent="0">
              <a:buNone/>
              <a:defRPr sz="843"/>
            </a:lvl8pPr>
            <a:lvl9pPr marL="3081528" indent="0">
              <a:buNone/>
              <a:defRPr sz="84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08581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9660" y="569242"/>
            <a:ext cx="664481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9660" y="2846200"/>
            <a:ext cx="664481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9660" y="9909729"/>
            <a:ext cx="173343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9B974-8F04-5943-86FB-365AFFD87770}" type="datetimeFigureOut">
              <a:rPr lang="en-JP" smtClean="0"/>
              <a:t>2023/09/1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51996" y="9909729"/>
            <a:ext cx="260014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41047" y="9909729"/>
            <a:ext cx="173343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8A0A2-BA10-3D42-A02F-B39C2462AE3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87145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0382" rtl="0" eaLnBrk="1" latinLnBrk="0" hangingPunct="1">
        <a:lnSpc>
          <a:spcPct val="90000"/>
        </a:lnSpc>
        <a:spcBef>
          <a:spcPct val="0"/>
        </a:spcBef>
        <a:buNone/>
        <a:defRPr sz="37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2596" indent="-192596" algn="l" defTabSz="770382" rtl="0" eaLnBrk="1" latinLnBrk="0" hangingPunct="1">
        <a:lnSpc>
          <a:spcPct val="90000"/>
        </a:lnSpc>
        <a:spcBef>
          <a:spcPts val="843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1pPr>
      <a:lvl2pPr marL="577787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2022" kern="1200">
          <a:solidFill>
            <a:schemeClr val="tx1"/>
          </a:solidFill>
          <a:latin typeface="+mn-lt"/>
          <a:ea typeface="+mn-ea"/>
          <a:cs typeface="+mn-cs"/>
        </a:defRPr>
      </a:lvl2pPr>
      <a:lvl3pPr marL="962978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685" kern="1200">
          <a:solidFill>
            <a:schemeClr val="tx1"/>
          </a:solidFill>
          <a:latin typeface="+mn-lt"/>
          <a:ea typeface="+mn-ea"/>
          <a:cs typeface="+mn-cs"/>
        </a:defRPr>
      </a:lvl3pPr>
      <a:lvl4pPr marL="1348169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4pPr>
      <a:lvl5pPr marL="1733360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5pPr>
      <a:lvl6pPr marL="2118551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6pPr>
      <a:lvl7pPr marL="2503742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7pPr>
      <a:lvl8pPr marL="2888933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8pPr>
      <a:lvl9pPr marL="3274124" indent="-192596" algn="l" defTabSz="770382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sz="15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1pPr>
      <a:lvl2pPr marL="385191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2pPr>
      <a:lvl3pPr marL="770382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3pPr>
      <a:lvl4pPr marL="1155573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4pPr>
      <a:lvl5pPr marL="1540764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5pPr>
      <a:lvl6pPr marL="1925955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6pPr>
      <a:lvl7pPr marL="2311146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7pPr>
      <a:lvl8pPr marL="2696337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8pPr>
      <a:lvl9pPr marL="3081528" algn="l" defTabSz="770382" rtl="0" eaLnBrk="1" latinLnBrk="0" hangingPunct="1">
        <a:defRPr sz="15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emf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png"/><Relationship Id="rId9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A56B175-BCF0-AFE1-1FF9-09D4DB4784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99802"/>
            <a:ext cx="7704138" cy="54922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6BDFE52-7B63-0314-17B2-5FEB80C523FD}"/>
              </a:ext>
            </a:extLst>
          </p:cNvPr>
          <p:cNvSpPr txBox="1"/>
          <p:nvPr/>
        </p:nvSpPr>
        <p:spPr>
          <a:xfrm>
            <a:off x="0" y="8239384"/>
            <a:ext cx="6705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enome analysis revealed the pathway of PHB metabolism.</a:t>
            </a:r>
          </a:p>
        </p:txBody>
      </p:sp>
    </p:spTree>
    <p:extLst>
      <p:ext uri="{BB962C8B-B14F-4D97-AF65-F5344CB8AC3E}">
        <p14:creationId xmlns:p14="http://schemas.microsoft.com/office/powerpoint/2010/main" val="3760697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710DF68-A3F3-59C0-A434-B2B70AABF07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809" t="10142" r="32936" b="9668"/>
          <a:stretch/>
        </p:blipFill>
        <p:spPr>
          <a:xfrm>
            <a:off x="202291" y="0"/>
            <a:ext cx="6267450" cy="101175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391054B-E90C-0053-9882-72DF790BB3AD}"/>
              </a:ext>
            </a:extLst>
          </p:cNvPr>
          <p:cNvSpPr txBox="1"/>
          <p:nvPr/>
        </p:nvSpPr>
        <p:spPr>
          <a:xfrm>
            <a:off x="178709" y="10195365"/>
            <a:ext cx="6314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Heatmap based on relative abundance of top100 ASVs.</a:t>
            </a:r>
          </a:p>
        </p:txBody>
      </p:sp>
    </p:spTree>
    <p:extLst>
      <p:ext uri="{BB962C8B-B14F-4D97-AF65-F5344CB8AC3E}">
        <p14:creationId xmlns:p14="http://schemas.microsoft.com/office/powerpoint/2010/main" val="2578112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2964E6-DE56-2AEB-032B-CF527D31A5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0454" y="1345649"/>
            <a:ext cx="6644819" cy="6783857"/>
          </a:xfrm>
        </p:spPr>
        <p:txBody>
          <a:bodyPr/>
          <a:lstStyle/>
          <a:p>
            <a:endParaRPr lang="en-JP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51BE6F9-50FF-5B49-9230-3DAB7E43EF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4281"/>
          <a:stretch/>
        </p:blipFill>
        <p:spPr>
          <a:xfrm>
            <a:off x="296863" y="0"/>
            <a:ext cx="7112000" cy="86220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E5B54A-6F59-CC42-9DAA-7C3AE99FC37B}"/>
              </a:ext>
            </a:extLst>
          </p:cNvPr>
          <p:cNvSpPr txBox="1"/>
          <p:nvPr/>
        </p:nvSpPr>
        <p:spPr>
          <a:xfrm>
            <a:off x="127884" y="8749596"/>
            <a:ext cx="7449958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3. The impact of seawater on microbiome of sea cucumber larvae analyzed by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SourceTracker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. a)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Barplot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of the proportion of sources in specific sample. b) Pie plot of proportion of sources in larval microbiome before and after gut development. SW-Before: seawater before larval gut development; SW-Post: seawater post larval gut development.</a:t>
            </a:r>
          </a:p>
          <a:p>
            <a:endParaRPr lang="en-JP" sz="1200" dirty="0"/>
          </a:p>
        </p:txBody>
      </p:sp>
    </p:spTree>
    <p:extLst>
      <p:ext uri="{BB962C8B-B14F-4D97-AF65-F5344CB8AC3E}">
        <p14:creationId xmlns:p14="http://schemas.microsoft.com/office/powerpoint/2010/main" val="1367448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graph with numbers and symbols&#10;&#10;Description automatically generated with medium confidence">
            <a:extLst>
              <a:ext uri="{FF2B5EF4-FFF2-40B4-BE49-F238E27FC236}">
                <a16:creationId xmlns:a16="http://schemas.microsoft.com/office/drawing/2014/main" id="{709BC4B1-46BA-FD1A-DF7D-558DEC9668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823" y="4665616"/>
            <a:ext cx="3530703" cy="3558799"/>
          </a:xfrm>
          <a:prstGeom prst="rect">
            <a:avLst/>
          </a:prstGeom>
        </p:spPr>
      </p:pic>
      <p:pic>
        <p:nvPicPr>
          <p:cNvPr id="9" name="Picture 8" descr="A graph with a number of words&#10;&#10;Description automatically generated with medium confidence">
            <a:extLst>
              <a:ext uri="{FF2B5EF4-FFF2-40B4-BE49-F238E27FC236}">
                <a16:creationId xmlns:a16="http://schemas.microsoft.com/office/drawing/2014/main" id="{F5FD7032-C907-C2D2-6A93-0D5A2CF089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28548" y="1119814"/>
            <a:ext cx="3475590" cy="264211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AB97A7E-3729-0BA4-BA1F-2278DF3C2B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119" y="1147495"/>
            <a:ext cx="3465920" cy="264211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4CF0D64-4637-8DE4-68F6-07BDC19FA6D4}"/>
              </a:ext>
            </a:extLst>
          </p:cNvPr>
          <p:cNvSpPr txBox="1"/>
          <p:nvPr/>
        </p:nvSpPr>
        <p:spPr>
          <a:xfrm rot="16200000">
            <a:off x="-1279371" y="2283886"/>
            <a:ext cx="2984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dirty="0"/>
              <a:t>Normalized core index (NorCI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80750E-CF3C-B1D2-80CD-3A6BF423F2A7}"/>
              </a:ext>
            </a:extLst>
          </p:cNvPr>
          <p:cNvSpPr txBox="1"/>
          <p:nvPr/>
        </p:nvSpPr>
        <p:spPr>
          <a:xfrm rot="16200000">
            <a:off x="2570942" y="2256205"/>
            <a:ext cx="2984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dirty="0"/>
              <a:t>Normalized core index (NorCI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FC62006-8BB7-DCD5-C3C9-8C3C8718D2F0}"/>
              </a:ext>
            </a:extLst>
          </p:cNvPr>
          <p:cNvSpPr txBox="1"/>
          <p:nvPr/>
        </p:nvSpPr>
        <p:spPr>
          <a:xfrm>
            <a:off x="168264" y="8625443"/>
            <a:ext cx="751021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igure S4. Normalized core index (</a:t>
            </a:r>
            <a:r>
              <a:rPr lang="en-US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NorCI</a:t>
            </a:r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for core bacteria in the sea cucumber larvae. a) </a:t>
            </a:r>
            <a:r>
              <a:rPr lang="en-US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NorCI</a:t>
            </a:r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of bacteria at family level in sea cucumber larvae before gut development. b)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orC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of bacteria at family level in sea cucumber larvae post gut development. c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)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NorC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of bacteria at genera level in sea cucumber samples. </a:t>
            </a:r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) </a:t>
            </a:r>
            <a:r>
              <a:rPr lang="en-US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NorCI</a:t>
            </a:r>
            <a:r>
              <a:rPr lang="en-US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of ASVs in sea cucumber samples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7646A7E-79B2-3564-7D6B-2CB4DF009DB0}"/>
              </a:ext>
            </a:extLst>
          </p:cNvPr>
          <p:cNvSpPr txBox="1"/>
          <p:nvPr/>
        </p:nvSpPr>
        <p:spPr>
          <a:xfrm>
            <a:off x="28213" y="699895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B460C9-3C41-DE45-0429-330C393A5BA0}"/>
              </a:ext>
            </a:extLst>
          </p:cNvPr>
          <p:cNvSpPr txBox="1"/>
          <p:nvPr/>
        </p:nvSpPr>
        <p:spPr>
          <a:xfrm>
            <a:off x="3852863" y="699895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5" name="Picture 4" descr="A graph with blue dots and stars&#10;&#10;Description automatically generated">
            <a:extLst>
              <a:ext uri="{FF2B5EF4-FFF2-40B4-BE49-F238E27FC236}">
                <a16:creationId xmlns:a16="http://schemas.microsoft.com/office/drawing/2014/main" id="{7F62B8FB-0BB3-0AE2-03E9-479AC86DF0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0700" y="4680380"/>
            <a:ext cx="3537407" cy="31928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ADD6485-F0E5-11B7-0CE0-CA1A7E6E35A5}"/>
              </a:ext>
            </a:extLst>
          </p:cNvPr>
          <p:cNvSpPr txBox="1"/>
          <p:nvPr/>
        </p:nvSpPr>
        <p:spPr>
          <a:xfrm rot="16200000">
            <a:off x="2570942" y="6136991"/>
            <a:ext cx="2984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dirty="0"/>
              <a:t>Normalized core index (NorCI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DD99386-E184-4ED3-8C66-7F04A7F4A7D3}"/>
              </a:ext>
            </a:extLst>
          </p:cNvPr>
          <p:cNvSpPr txBox="1"/>
          <p:nvPr/>
        </p:nvSpPr>
        <p:spPr>
          <a:xfrm rot="16200000">
            <a:off x="-1279372" y="6108456"/>
            <a:ext cx="2984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dirty="0"/>
              <a:t>Normalized core index (NorCI)</a:t>
            </a:r>
          </a:p>
        </p:txBody>
      </p:sp>
    </p:spTree>
    <p:extLst>
      <p:ext uri="{BB962C8B-B14F-4D97-AF65-F5344CB8AC3E}">
        <p14:creationId xmlns:p14="http://schemas.microsoft.com/office/powerpoint/2010/main" val="273861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02BDCD8-3399-033B-2E58-FFBF70B8F0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084239" y="-1084239"/>
            <a:ext cx="5223663" cy="739214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306A955-C6F4-07D1-AE7B-F1C2718710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1084239" y="2731835"/>
            <a:ext cx="5223663" cy="739214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65A2AC3-6166-4DFC-723F-230441082106}"/>
              </a:ext>
            </a:extLst>
          </p:cNvPr>
          <p:cNvSpPr txBox="1"/>
          <p:nvPr/>
        </p:nvSpPr>
        <p:spPr>
          <a:xfrm>
            <a:off x="168264" y="8625443"/>
            <a:ext cx="75102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igure S5. R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refaction curve of a) sea cucumber samples and b) seawater samples.</a:t>
            </a:r>
            <a:endParaRPr lang="en-US" b="1" dirty="0">
              <a:solidFill>
                <a:srgbClr val="000000"/>
              </a:solidFill>
              <a:effectLst/>
              <a:latin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309601-2101-3CA0-A150-B6E01D1A2B60}"/>
              </a:ext>
            </a:extLst>
          </p:cNvPr>
          <p:cNvSpPr txBox="1"/>
          <p:nvPr/>
        </p:nvSpPr>
        <p:spPr>
          <a:xfrm>
            <a:off x="28213" y="1007479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1EBFDD-10F7-D9DF-92E4-CDDD27EE6CFB}"/>
              </a:ext>
            </a:extLst>
          </p:cNvPr>
          <p:cNvSpPr txBox="1"/>
          <p:nvPr/>
        </p:nvSpPr>
        <p:spPr>
          <a:xfrm>
            <a:off x="28213" y="4823553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914080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076D8B3-9C32-170D-85D7-7DB898A4C5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271" t="6748" r="2350" b="30436"/>
          <a:stretch/>
        </p:blipFill>
        <p:spPr>
          <a:xfrm>
            <a:off x="302371" y="3244345"/>
            <a:ext cx="3382641" cy="20339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diagram of different colored triangles&#10;&#10;Description automatically generated">
            <a:extLst>
              <a:ext uri="{FF2B5EF4-FFF2-40B4-BE49-F238E27FC236}">
                <a16:creationId xmlns:a16="http://schemas.microsoft.com/office/drawing/2014/main" id="{0213CDA1-1F27-D80D-8E58-0A86F27D4FC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543" b="5316"/>
          <a:stretch/>
        </p:blipFill>
        <p:spPr>
          <a:xfrm>
            <a:off x="210171" y="287990"/>
            <a:ext cx="3704256" cy="236047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E49061-2F63-0834-829F-4C8F7BFC5E4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719" t="7947" r="342" b="30666"/>
          <a:stretch/>
        </p:blipFill>
        <p:spPr>
          <a:xfrm>
            <a:off x="4299074" y="3244345"/>
            <a:ext cx="3306693" cy="20339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502B500-E769-882D-5E9C-7D263A71E738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l="10442" t="6379" r="2445" b="46463"/>
          <a:stretch/>
        </p:blipFill>
        <p:spPr>
          <a:xfrm>
            <a:off x="4262614" y="522177"/>
            <a:ext cx="3343152" cy="2318511"/>
          </a:xfrm>
          <a:prstGeom prst="rect">
            <a:avLst/>
          </a:prstGeom>
          <a:ln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4BABD56-7675-8729-5875-7329D4143B50}"/>
              </a:ext>
            </a:extLst>
          </p:cNvPr>
          <p:cNvSpPr txBox="1"/>
          <p:nvPr/>
        </p:nvSpPr>
        <p:spPr>
          <a:xfrm>
            <a:off x="653209" y="5335495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019</a:t>
            </a:r>
            <a:endParaRPr lang="en-JP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191BA5-7ACF-4EAA-ABEA-BB2FB0C1C565}"/>
              </a:ext>
            </a:extLst>
          </p:cNvPr>
          <p:cNvSpPr txBox="1"/>
          <p:nvPr/>
        </p:nvSpPr>
        <p:spPr>
          <a:xfrm>
            <a:off x="1839793" y="5334220"/>
            <a:ext cx="652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020</a:t>
            </a:r>
            <a:endParaRPr lang="en-JP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605542-CF8E-9B57-0E68-BFDFA8D048C9}"/>
              </a:ext>
            </a:extLst>
          </p:cNvPr>
          <p:cNvSpPr txBox="1"/>
          <p:nvPr/>
        </p:nvSpPr>
        <p:spPr>
          <a:xfrm>
            <a:off x="2961885" y="5334220"/>
            <a:ext cx="652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021</a:t>
            </a:r>
            <a:endParaRPr lang="en-JP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2536A8E-F05D-80B8-E7A7-A9E1C816FB52}"/>
              </a:ext>
            </a:extLst>
          </p:cNvPr>
          <p:cNvSpPr txBox="1"/>
          <p:nvPr/>
        </p:nvSpPr>
        <p:spPr>
          <a:xfrm>
            <a:off x="4681488" y="5334220"/>
            <a:ext cx="78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preG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3D19278-D7E9-64BF-9881-144AAEB439A3}"/>
              </a:ext>
            </a:extLst>
          </p:cNvPr>
          <p:cNvSpPr txBox="1"/>
          <p:nvPr/>
        </p:nvSpPr>
        <p:spPr>
          <a:xfrm>
            <a:off x="6390269" y="5332945"/>
            <a:ext cx="881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postG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60D3094-54F2-B6FA-1D3C-ED9198657B10}"/>
              </a:ext>
            </a:extLst>
          </p:cNvPr>
          <p:cNvSpPr txBox="1"/>
          <p:nvPr/>
        </p:nvSpPr>
        <p:spPr>
          <a:xfrm>
            <a:off x="6724048" y="4963613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0.001</a:t>
            </a:r>
            <a:endParaRPr lang="en-JP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197C2E-76D4-B505-93B6-299BC955FC6B}"/>
              </a:ext>
            </a:extLst>
          </p:cNvPr>
          <p:cNvSpPr txBox="1"/>
          <p:nvPr/>
        </p:nvSpPr>
        <p:spPr>
          <a:xfrm>
            <a:off x="4262614" y="522177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4196C46-CD74-F2CC-8F2F-189338FCF07D}"/>
              </a:ext>
            </a:extLst>
          </p:cNvPr>
          <p:cNvSpPr txBox="1"/>
          <p:nvPr/>
        </p:nvSpPr>
        <p:spPr>
          <a:xfrm>
            <a:off x="4849670" y="522177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0346112-9704-5B7E-F546-5CA4738676D9}"/>
              </a:ext>
            </a:extLst>
          </p:cNvPr>
          <p:cNvSpPr txBox="1"/>
          <p:nvPr/>
        </p:nvSpPr>
        <p:spPr>
          <a:xfrm>
            <a:off x="5436726" y="522177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24C4D4-AF5F-15A5-2AB0-8DFF4B384903}"/>
              </a:ext>
            </a:extLst>
          </p:cNvPr>
          <p:cNvSpPr txBox="1"/>
          <p:nvPr/>
        </p:nvSpPr>
        <p:spPr>
          <a:xfrm>
            <a:off x="6071917" y="337511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1111FD6-D4AD-13DC-FC33-B1CCBB9A05E8}"/>
              </a:ext>
            </a:extLst>
          </p:cNvPr>
          <p:cNvSpPr txBox="1"/>
          <p:nvPr/>
        </p:nvSpPr>
        <p:spPr>
          <a:xfrm>
            <a:off x="6626007" y="337511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00199F-C7D0-0E24-025A-809D5D83BB94}"/>
              </a:ext>
            </a:extLst>
          </p:cNvPr>
          <p:cNvSpPr txBox="1"/>
          <p:nvPr/>
        </p:nvSpPr>
        <p:spPr>
          <a:xfrm>
            <a:off x="7197894" y="337511"/>
            <a:ext cx="490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6AF43E-1703-2CF1-CE71-D2DA3BFFA411}"/>
              </a:ext>
            </a:extLst>
          </p:cNvPr>
          <p:cNvSpPr txBox="1"/>
          <p:nvPr/>
        </p:nvSpPr>
        <p:spPr>
          <a:xfrm>
            <a:off x="4223125" y="2692461"/>
            <a:ext cx="494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F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125C370-7A91-2436-70A3-AFAC81332230}"/>
              </a:ext>
            </a:extLst>
          </p:cNvPr>
          <p:cNvSpPr txBox="1"/>
          <p:nvPr/>
        </p:nvSpPr>
        <p:spPr>
          <a:xfrm>
            <a:off x="4812770" y="2692461"/>
            <a:ext cx="494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G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E3160C-2781-F24A-8074-A3D10F9AE3D9}"/>
              </a:ext>
            </a:extLst>
          </p:cNvPr>
          <p:cNvSpPr txBox="1"/>
          <p:nvPr/>
        </p:nvSpPr>
        <p:spPr>
          <a:xfrm>
            <a:off x="5402415" y="2692461"/>
            <a:ext cx="494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E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7D1D061-DCA5-89CE-32F2-0773FEFA1285}"/>
              </a:ext>
            </a:extLst>
          </p:cNvPr>
          <p:cNvSpPr txBox="1"/>
          <p:nvPr/>
        </p:nvSpPr>
        <p:spPr>
          <a:xfrm>
            <a:off x="5992060" y="2692461"/>
            <a:ext cx="494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L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4DE3C5-DEF4-FF15-B4CD-1554C45882E4}"/>
              </a:ext>
            </a:extLst>
          </p:cNvPr>
          <p:cNvSpPr txBox="1"/>
          <p:nvPr/>
        </p:nvSpPr>
        <p:spPr>
          <a:xfrm>
            <a:off x="6581705" y="2692461"/>
            <a:ext cx="494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P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206D24C-7AE0-A63C-580A-FEE888B3FD8D}"/>
              </a:ext>
            </a:extLst>
          </p:cNvPr>
          <p:cNvSpPr txBox="1"/>
          <p:nvPr/>
        </p:nvSpPr>
        <p:spPr>
          <a:xfrm>
            <a:off x="7171351" y="2692461"/>
            <a:ext cx="500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JN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2579867-457B-4BF4-7F80-E7D4E3A88D9F}"/>
              </a:ext>
            </a:extLst>
          </p:cNvPr>
          <p:cNvSpPr/>
          <p:nvPr/>
        </p:nvSpPr>
        <p:spPr>
          <a:xfrm>
            <a:off x="4262614" y="337511"/>
            <a:ext cx="3343152" cy="231851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D9279F0-E5E3-A6EB-5E78-308AD6054254}"/>
              </a:ext>
            </a:extLst>
          </p:cNvPr>
          <p:cNvSpPr txBox="1"/>
          <p:nvPr/>
        </p:nvSpPr>
        <p:spPr>
          <a:xfrm>
            <a:off x="117017" y="8292723"/>
            <a:ext cx="7587121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igure S6. Beta diversity of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weighted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UniFrac distance of larval microbiome. a)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CoA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lot based on weighted UniFrac distance showing the microbiota differences in different years.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ifferent color represent different years; closed circle represent larvae samples before gut development, triangle represent larvae samples post gut development. </a:t>
            </a:r>
          </a:p>
          <a:p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) Weighted UniFrac distance plot between different developmental stage.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 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) Weighted UniFrac distance plots between different years and d) between sea cucumber before and post gut development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PERMANOVA, </a:t>
            </a:r>
            <a:r>
              <a:rPr lang="en-US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0.05).e)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CoA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lot based on weighted UniFrac distance of seawater and sea cucumber microbiotas. Different color represent developmental stages; closed circle represent larval samples; open circles represent the seawater samples. f) Weighted UniFrac distance plot between sea cucumber and seawater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PERMANOVA, </a:t>
            </a:r>
            <a:r>
              <a:rPr lang="en-US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0.05, </a:t>
            </a:r>
            <a:r>
              <a:rPr lang="en-US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q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0.05)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F94522-E130-EA63-D8CB-1C3FCE1A8654}"/>
              </a:ext>
            </a:extLst>
          </p:cNvPr>
          <p:cNvSpPr txBox="1"/>
          <p:nvPr/>
        </p:nvSpPr>
        <p:spPr>
          <a:xfrm>
            <a:off x="-918" y="183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2838BEC-D3C9-E7EB-0959-33F77725E8B0}"/>
              </a:ext>
            </a:extLst>
          </p:cNvPr>
          <p:cNvSpPr txBox="1"/>
          <p:nvPr/>
        </p:nvSpPr>
        <p:spPr>
          <a:xfrm>
            <a:off x="3921139" y="183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006FC9A-044F-CB22-7982-60D50D9C0BAD}"/>
              </a:ext>
            </a:extLst>
          </p:cNvPr>
          <p:cNvSpPr txBox="1"/>
          <p:nvPr/>
        </p:nvSpPr>
        <p:spPr>
          <a:xfrm>
            <a:off x="3821260" y="286470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E5A91E2-BD80-3515-3406-2CA3448D3FF5}"/>
              </a:ext>
            </a:extLst>
          </p:cNvPr>
          <p:cNvSpPr txBox="1"/>
          <p:nvPr/>
        </p:nvSpPr>
        <p:spPr>
          <a:xfrm>
            <a:off x="-4124" y="2803551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c</a:t>
            </a:r>
          </a:p>
        </p:txBody>
      </p:sp>
      <p:pic>
        <p:nvPicPr>
          <p:cNvPr id="38" name="Picture 37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A1BACC36-AAE0-55F2-2EE4-14F67CD7A32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2717" r="3925" b="9261"/>
          <a:stretch/>
        </p:blipFill>
        <p:spPr>
          <a:xfrm>
            <a:off x="210172" y="5593011"/>
            <a:ext cx="3642691" cy="2520721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5D99DC49-4BF5-97DE-472D-F22FF30CEF8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0394" t="6549" r="3702" b="43834"/>
          <a:stretch/>
        </p:blipFill>
        <p:spPr>
          <a:xfrm>
            <a:off x="4299073" y="5876905"/>
            <a:ext cx="3306693" cy="2033984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4F705566-DFF1-0A0D-1CDC-473AEF689377}"/>
              </a:ext>
            </a:extLst>
          </p:cNvPr>
          <p:cNvSpPr txBox="1"/>
          <p:nvPr/>
        </p:nvSpPr>
        <p:spPr>
          <a:xfrm>
            <a:off x="48857" y="5572706"/>
            <a:ext cx="45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13CF50C-EA9F-8434-DD85-D34E00842138}"/>
              </a:ext>
            </a:extLst>
          </p:cNvPr>
          <p:cNvSpPr txBox="1"/>
          <p:nvPr/>
        </p:nvSpPr>
        <p:spPr>
          <a:xfrm>
            <a:off x="3921140" y="5557546"/>
            <a:ext cx="458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/>
              <a:t>f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BBCBCF8-7E07-749F-4E12-3758364724F8}"/>
              </a:ext>
            </a:extLst>
          </p:cNvPr>
          <p:cNvSpPr txBox="1"/>
          <p:nvPr/>
        </p:nvSpPr>
        <p:spPr>
          <a:xfrm>
            <a:off x="4380077" y="7874450"/>
            <a:ext cx="1510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Sea cucumber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9CCE7C7-4554-2C22-76AD-BF36A0A06608}"/>
              </a:ext>
            </a:extLst>
          </p:cNvPr>
          <p:cNvSpPr txBox="1"/>
          <p:nvPr/>
        </p:nvSpPr>
        <p:spPr>
          <a:xfrm>
            <a:off x="6317596" y="7888528"/>
            <a:ext cx="1055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Seawater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9289EC64-667A-3907-19F6-D66BF1BACA3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22118" y="5845132"/>
            <a:ext cx="457200" cy="219710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1FB1EB8C-513D-7218-7414-8C8A519B332B}"/>
              </a:ext>
            </a:extLst>
          </p:cNvPr>
          <p:cNvSpPr txBox="1"/>
          <p:nvPr/>
        </p:nvSpPr>
        <p:spPr>
          <a:xfrm>
            <a:off x="3976911" y="243421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664AE90-55A1-B841-A3AD-5B372F764820}"/>
              </a:ext>
            </a:extLst>
          </p:cNvPr>
          <p:cNvSpPr txBox="1"/>
          <p:nvPr/>
        </p:nvSpPr>
        <p:spPr>
          <a:xfrm>
            <a:off x="3979715" y="506755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E3BB3C5-FE2A-7BDB-B7AF-D5A76FF839CA}"/>
              </a:ext>
            </a:extLst>
          </p:cNvPr>
          <p:cNvSpPr txBox="1"/>
          <p:nvPr/>
        </p:nvSpPr>
        <p:spPr>
          <a:xfrm>
            <a:off x="-4123" y="511217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345E0BC-B02C-3BC4-E249-553DEBC40470}"/>
              </a:ext>
            </a:extLst>
          </p:cNvPr>
          <p:cNvSpPr txBox="1"/>
          <p:nvPr/>
        </p:nvSpPr>
        <p:spPr>
          <a:xfrm rot="16200000">
            <a:off x="3603137" y="1310387"/>
            <a:ext cx="9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Distanc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4E30286-6F10-104F-0B65-85D23A1922EE}"/>
              </a:ext>
            </a:extLst>
          </p:cNvPr>
          <p:cNvSpPr txBox="1"/>
          <p:nvPr/>
        </p:nvSpPr>
        <p:spPr>
          <a:xfrm>
            <a:off x="3822661" y="267760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.9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A2428D1-8492-EC0F-8AD3-7BD181E5FE71}"/>
              </a:ext>
            </a:extLst>
          </p:cNvPr>
          <p:cNvSpPr txBox="1"/>
          <p:nvPr/>
        </p:nvSpPr>
        <p:spPr>
          <a:xfrm rot="16200000">
            <a:off x="3603138" y="4082372"/>
            <a:ext cx="9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Distanc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29DAD68-6543-1376-DD6C-EB7C22C05C70}"/>
              </a:ext>
            </a:extLst>
          </p:cNvPr>
          <p:cNvSpPr txBox="1"/>
          <p:nvPr/>
        </p:nvSpPr>
        <p:spPr>
          <a:xfrm>
            <a:off x="3822662" y="3116348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.9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A0740ED-D28E-E790-E47E-FCEF5FB80765}"/>
              </a:ext>
            </a:extLst>
          </p:cNvPr>
          <p:cNvSpPr txBox="1"/>
          <p:nvPr/>
        </p:nvSpPr>
        <p:spPr>
          <a:xfrm rot="16200000">
            <a:off x="-375892" y="4166103"/>
            <a:ext cx="9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Distanc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92963E4-75D3-0451-41FC-0240BC8435DB}"/>
              </a:ext>
            </a:extLst>
          </p:cNvPr>
          <p:cNvSpPr txBox="1"/>
          <p:nvPr/>
        </p:nvSpPr>
        <p:spPr>
          <a:xfrm>
            <a:off x="-121189" y="3099185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.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465B1A3-4FEE-6313-D11C-984703E4CB5E}"/>
              </a:ext>
            </a:extLst>
          </p:cNvPr>
          <p:cNvSpPr txBox="1"/>
          <p:nvPr/>
        </p:nvSpPr>
        <p:spPr>
          <a:xfrm>
            <a:off x="3979715" y="772222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FFC65A6-047C-6CAA-1744-FF60AD5E9179}"/>
              </a:ext>
            </a:extLst>
          </p:cNvPr>
          <p:cNvSpPr txBox="1"/>
          <p:nvPr/>
        </p:nvSpPr>
        <p:spPr>
          <a:xfrm rot="16200000">
            <a:off x="3603138" y="6776154"/>
            <a:ext cx="9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Distanc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6069A4B-96A4-F0BF-DAFF-FA22EBEADA99}"/>
              </a:ext>
            </a:extLst>
          </p:cNvPr>
          <p:cNvSpPr txBox="1"/>
          <p:nvPr/>
        </p:nvSpPr>
        <p:spPr>
          <a:xfrm>
            <a:off x="3822662" y="578348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0.9</a:t>
            </a: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E9567B37-C78D-55C4-C114-7576D677A4E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60107" y="230824"/>
            <a:ext cx="803435" cy="926182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558FBCF8-5CCF-EABC-E3C6-DA912BDDEDD4}"/>
              </a:ext>
            </a:extLst>
          </p:cNvPr>
          <p:cNvSpPr txBox="1"/>
          <p:nvPr/>
        </p:nvSpPr>
        <p:spPr>
          <a:xfrm>
            <a:off x="4326188" y="5822289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0.023</a:t>
            </a:r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1450684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848</TotalTime>
  <Words>399</Words>
  <Application>Microsoft Macintosh PowerPoint</Application>
  <PresentationFormat>Custom</PresentationFormat>
  <Paragraphs>57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？　？文</dc:creator>
  <cp:lastModifiedBy>？　？文</cp:lastModifiedBy>
  <cp:revision>9</cp:revision>
  <dcterms:created xsi:type="dcterms:W3CDTF">2023-03-28T02:24:33Z</dcterms:created>
  <dcterms:modified xsi:type="dcterms:W3CDTF">2023-09-14T02:41:46Z</dcterms:modified>
</cp:coreProperties>
</file>